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579" r:id="rId2"/>
    <p:sldId id="580" r:id="rId3"/>
    <p:sldId id="541" r:id="rId4"/>
    <p:sldId id="546" r:id="rId5"/>
  </p:sldIdLst>
  <p:sldSz cx="6858000" cy="9144000" type="letter"/>
  <p:notesSz cx="6985000" cy="92837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156A68F-C046-0446-ADF3-2596E86B3D8F}" v="30" dt="2022-11-02T21:27:28.22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 autoAdjust="0"/>
    <p:restoredTop sz="98718" autoAdjust="0"/>
  </p:normalViewPr>
  <p:slideViewPr>
    <p:cSldViewPr>
      <p:cViewPr>
        <p:scale>
          <a:sx n="110" d="100"/>
          <a:sy n="110" d="100"/>
        </p:scale>
        <p:origin x="1912" y="-51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1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137B9D79-8F52-49CB-A70C-4BE645CB61BE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96913"/>
            <a:ext cx="2609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14" tIns="46456" rIns="92914" bIns="46456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14" tIns="46456" rIns="92914" bIns="46456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14" tIns="46456" rIns="92914" bIns="46456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089EDEE8-FD63-4A2A-A616-5B773F97CB9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097585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EF0E9B-B36B-4DBC-A70B-F537A3618EDD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C3173-9CC3-4B6D-A2D8-9356507D809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D41CD4-85B0-4BBA-918C-1682C5B45D2B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29C65E-089B-483A-965C-9296153F332C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5EADC2-F028-449F-BBCD-925F4B619934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B86C6E-4534-4C46-83C5-D9C9AB62B92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69D744-5FD2-40B4-9265-906A30839144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DBE50-1E95-4EA2-BD8A-1264D9AADFD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114B9F-C602-4030-93E0-B9D87ED3B2A2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A37417-D9B5-4FF1-9EE8-E5C80EEDA62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4CAAAD-A356-43C4-BAD8-0BE3732EFD4D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350397-FD29-4078-8FB5-2A5C7142EED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9F1943-EC0D-4288-8F90-7353B45A7687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51E81D-3A67-43D4-ABA9-78080DF070F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DBACD-33AD-4DCC-9516-E7A4742D4AA1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385B6-BC9E-4A70-9052-077A7330F67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A217BC-B11A-4201-93E4-D0FA7F176FDE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BF3A92-8D3E-42A1-A63A-535E2DD7565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A71C1D-1320-4394-AF54-E37B74D1A321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5B7A68-76FF-46C3-A1F1-C00FF7C0E7F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E95595-0F64-4B07-8FCF-D585C428D723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C154A1-5D10-4762-A2B3-AB3B85665C71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2048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395308DC-A758-486B-B27C-A3507D672B48}" type="datetimeFigureOut">
              <a:rPr lang="en-US"/>
              <a:pPr>
                <a:defRPr/>
              </a:pPr>
              <a:t>1/4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CEC38C9-2618-45DC-BF65-D13E3711339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-13850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-13850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397"/>
          <p:cNvSpPr>
            <a:spLocks noChangeArrowheads="1"/>
          </p:cNvSpPr>
          <p:nvPr/>
        </p:nvSpPr>
        <p:spPr bwMode="auto">
          <a:xfrm>
            <a:off x="0" y="-13850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399"/>
          <p:cNvSpPr>
            <a:spLocks noChangeArrowheads="1"/>
          </p:cNvSpPr>
          <p:nvPr/>
        </p:nvSpPr>
        <p:spPr bwMode="auto">
          <a:xfrm>
            <a:off x="0" y="-13850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A47F83B-0E2E-48D5-814D-F2BDD7E501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2460664"/>
              </p:ext>
            </p:extLst>
          </p:nvPr>
        </p:nvGraphicFramePr>
        <p:xfrm>
          <a:off x="1828800" y="1143000"/>
          <a:ext cx="2971800" cy="4495800"/>
        </p:xfrm>
        <a:graphic>
          <a:graphicData uri="http://schemas.openxmlformats.org/drawingml/2006/table">
            <a:tbl>
              <a:tblPr/>
              <a:tblGrid>
                <a:gridCol w="1485900">
                  <a:extLst>
                    <a:ext uri="{9D8B030D-6E8A-4147-A177-3AD203B41FA5}">
                      <a16:colId xmlns:a16="http://schemas.microsoft.com/office/drawing/2014/main" val="2941869603"/>
                    </a:ext>
                  </a:extLst>
                </a:gridCol>
                <a:gridCol w="1485900">
                  <a:extLst>
                    <a:ext uri="{9D8B030D-6E8A-4147-A177-3AD203B41FA5}">
                      <a16:colId xmlns:a16="http://schemas.microsoft.com/office/drawing/2014/main" val="3109470156"/>
                    </a:ext>
                  </a:extLst>
                </a:gridCol>
              </a:tblGrid>
              <a:tr h="2286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S1. HQ IC</a:t>
                      </a:r>
                      <a:r>
                        <a:rPr lang="en-US" sz="1200" b="1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lues in CRC cel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597542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Q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(mg/ml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1945373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T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0 ± 0.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7355381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K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 ± 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6867269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KO-R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 ± 0.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0444572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3 ± 0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4076300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30-R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1 ± 0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1451879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T116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 ± 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5471759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T116 PUMA(-/-)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 ± 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4776343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T116 p53(-/-)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 ± 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2788847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T116 p21(-/-)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 ± 0.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015987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W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4 ± 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5401335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 ± 0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6871603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D841 (Normal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9 ± 0.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5879137"/>
                  </a:ext>
                </a:extLst>
              </a:tr>
              <a:tr h="428625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l IC</a:t>
                      </a:r>
                      <a:r>
                        <a:rPr lang="en-US" sz="12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lues represent the mean ± SD from 3-5 independent experiments.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70430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235519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-13850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6D13885-EEA2-465F-913B-0B4FBCE904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4476648"/>
              </p:ext>
            </p:extLst>
          </p:nvPr>
        </p:nvGraphicFramePr>
        <p:xfrm>
          <a:off x="635000" y="1066800"/>
          <a:ext cx="5588000" cy="2895600"/>
        </p:xfrm>
        <a:graphic>
          <a:graphicData uri="http://schemas.openxmlformats.org/drawingml/2006/table">
            <a:tbl>
              <a:tblPr/>
              <a:tblGrid>
                <a:gridCol w="1397000">
                  <a:extLst>
                    <a:ext uri="{9D8B030D-6E8A-4147-A177-3AD203B41FA5}">
                      <a16:colId xmlns:a16="http://schemas.microsoft.com/office/drawing/2014/main" val="367686307"/>
                    </a:ext>
                  </a:extLst>
                </a:gridCol>
                <a:gridCol w="1397000">
                  <a:extLst>
                    <a:ext uri="{9D8B030D-6E8A-4147-A177-3AD203B41FA5}">
                      <a16:colId xmlns:a16="http://schemas.microsoft.com/office/drawing/2014/main" val="2786392247"/>
                    </a:ext>
                  </a:extLst>
                </a:gridCol>
                <a:gridCol w="1397000">
                  <a:extLst>
                    <a:ext uri="{9D8B030D-6E8A-4147-A177-3AD203B41FA5}">
                      <a16:colId xmlns:a16="http://schemas.microsoft.com/office/drawing/2014/main" val="2868628932"/>
                    </a:ext>
                  </a:extLst>
                </a:gridCol>
                <a:gridCol w="1397000">
                  <a:extLst>
                    <a:ext uri="{9D8B030D-6E8A-4147-A177-3AD203B41FA5}">
                      <a16:colId xmlns:a16="http://schemas.microsoft.com/office/drawing/2014/main" val="3764110621"/>
                    </a:ext>
                  </a:extLst>
                </a:gridCol>
              </a:tblGrid>
              <a:tr h="400050">
                <a:tc gridSpan="4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S2. IC</a:t>
                      </a:r>
                      <a:r>
                        <a:rPr lang="en-US" sz="12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lues of HQ against  colon cancer cell li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0183894"/>
                  </a:ext>
                </a:extLst>
              </a:tr>
              <a:tr h="4000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Q batch #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Q batch #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Q batch #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3302676"/>
                  </a:ext>
                </a:extLst>
              </a:tr>
              <a:tr h="4000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T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0 ± 0.06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8 ± 0.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3 ± 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1325832"/>
                  </a:ext>
                </a:extLst>
              </a:tr>
              <a:tr h="4000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KO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 ± 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 ± 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 ± 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7606588"/>
                  </a:ext>
                </a:extLst>
              </a:tr>
              <a:tr h="4000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T116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 ± 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 ± 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 ± 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0808184"/>
                  </a:ext>
                </a:extLst>
              </a:tr>
              <a:tr h="40005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3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 ± 0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 ± 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2 ± 0.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0180131"/>
                  </a:ext>
                </a:extLst>
              </a:tr>
              <a:tr h="495300">
                <a:tc gridSpan="4"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l IC</a:t>
                      </a:r>
                      <a:r>
                        <a:rPr lang="en-US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lues represent the mean ± SD from 3-5 independent experiments.</a:t>
                      </a:r>
                    </a:p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IC</a:t>
                      </a:r>
                      <a:r>
                        <a:rPr lang="en-US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lues from Table 2.  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5201541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7941325-852A-7E42-A7E0-B37CE01377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2774428"/>
              </p:ext>
            </p:extLst>
          </p:nvPr>
        </p:nvGraphicFramePr>
        <p:xfrm>
          <a:off x="812799" y="4954905"/>
          <a:ext cx="4749801" cy="2261235"/>
        </p:xfrm>
        <a:graphic>
          <a:graphicData uri="http://schemas.openxmlformats.org/drawingml/2006/table">
            <a:tbl>
              <a:tblPr/>
              <a:tblGrid>
                <a:gridCol w="923859">
                  <a:extLst>
                    <a:ext uri="{9D8B030D-6E8A-4147-A177-3AD203B41FA5}">
                      <a16:colId xmlns:a16="http://schemas.microsoft.com/office/drawing/2014/main" val="2079035976"/>
                    </a:ext>
                  </a:extLst>
                </a:gridCol>
                <a:gridCol w="806277">
                  <a:extLst>
                    <a:ext uri="{9D8B030D-6E8A-4147-A177-3AD203B41FA5}">
                      <a16:colId xmlns:a16="http://schemas.microsoft.com/office/drawing/2014/main" val="1709928294"/>
                    </a:ext>
                  </a:extLst>
                </a:gridCol>
                <a:gridCol w="806277">
                  <a:extLst>
                    <a:ext uri="{9D8B030D-6E8A-4147-A177-3AD203B41FA5}">
                      <a16:colId xmlns:a16="http://schemas.microsoft.com/office/drawing/2014/main" val="3689769511"/>
                    </a:ext>
                  </a:extLst>
                </a:gridCol>
                <a:gridCol w="806277">
                  <a:extLst>
                    <a:ext uri="{9D8B030D-6E8A-4147-A177-3AD203B41FA5}">
                      <a16:colId xmlns:a16="http://schemas.microsoft.com/office/drawing/2014/main" val="3129347628"/>
                    </a:ext>
                  </a:extLst>
                </a:gridCol>
                <a:gridCol w="670509">
                  <a:extLst>
                    <a:ext uri="{9D8B030D-6E8A-4147-A177-3AD203B41FA5}">
                      <a16:colId xmlns:a16="http://schemas.microsoft.com/office/drawing/2014/main" val="86470209"/>
                    </a:ext>
                  </a:extLst>
                </a:gridCol>
                <a:gridCol w="736602">
                  <a:extLst>
                    <a:ext uri="{9D8B030D-6E8A-4147-A177-3AD203B41FA5}">
                      <a16:colId xmlns:a16="http://schemas.microsoft.com/office/drawing/2014/main" val="1885343632"/>
                    </a:ext>
                  </a:extLst>
                </a:gridCol>
              </a:tblGrid>
              <a:tr h="266700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S3. Flavone concentration in three different HQ batches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6401852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avo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tch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tch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tch 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an 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% of HQ solu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6736438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ical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1522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icale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7668806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ogonosid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195026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ogon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1689293"/>
                  </a:ext>
                </a:extLst>
              </a:tr>
              <a:tr h="400050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avones (µg/ml) in HQ (50 µg/ml).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74217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426946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07"/>
          <p:cNvSpPr>
            <a:spLocks noChangeArrowheads="1"/>
          </p:cNvSpPr>
          <p:nvPr/>
        </p:nvSpPr>
        <p:spPr bwMode="auto">
          <a:xfrm>
            <a:off x="9887" y="-429075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111"/>
          <p:cNvSpPr>
            <a:spLocks noChangeArrowheads="1"/>
          </p:cNvSpPr>
          <p:nvPr/>
        </p:nvSpPr>
        <p:spPr bwMode="auto">
          <a:xfrm>
            <a:off x="9887" y="-429075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1121"/>
          <p:cNvSpPr>
            <a:spLocks noChangeArrowheads="1"/>
          </p:cNvSpPr>
          <p:nvPr/>
        </p:nvSpPr>
        <p:spPr bwMode="auto">
          <a:xfrm>
            <a:off x="0" y="-13850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125"/>
          <p:cNvSpPr>
            <a:spLocks noChangeArrowheads="1"/>
          </p:cNvSpPr>
          <p:nvPr/>
        </p:nvSpPr>
        <p:spPr bwMode="auto">
          <a:xfrm>
            <a:off x="0" y="-138500"/>
            <a:ext cx="1847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A06BEF1-12FF-4C07-B23C-A51E344932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4385596"/>
              </p:ext>
            </p:extLst>
          </p:nvPr>
        </p:nvGraphicFramePr>
        <p:xfrm>
          <a:off x="1143000" y="1428750"/>
          <a:ext cx="3911600" cy="3514725"/>
        </p:xfrm>
        <a:graphic>
          <a:graphicData uri="http://schemas.openxmlformats.org/drawingml/2006/table">
            <a:tbl>
              <a:tblPr/>
              <a:tblGrid>
                <a:gridCol w="977900">
                  <a:extLst>
                    <a:ext uri="{9D8B030D-6E8A-4147-A177-3AD203B41FA5}">
                      <a16:colId xmlns:a16="http://schemas.microsoft.com/office/drawing/2014/main" val="3654997908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995821108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3197902209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2246216838"/>
                    </a:ext>
                  </a:extLst>
                </a:gridCol>
              </a:tblGrid>
              <a:tr h="323850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Table S4. Proteins altered following HQ treatme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81290928"/>
                  </a:ext>
                </a:extLst>
              </a:tr>
              <a:tr h="32385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Increas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Decreas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178657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PU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9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p-R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-54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7324092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p-NF</a:t>
                      </a:r>
                      <a:r>
                        <a:rPr lang="el-GR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κ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B-p6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5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HK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-3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021015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p-NDRG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12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HSP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-4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060794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CYCLIN B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-3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382315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l" fontAlgn="ctr"/>
                      <a:endParaRPr lang="en-US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STAT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-3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0262831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 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MCL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-2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9895040"/>
                  </a:ext>
                </a:extLst>
              </a:tr>
              <a:tr h="590550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HT-29 cells were treated for 48 </a:t>
                      </a:r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hr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 with 0.5 mg/ml HQ. Cells were processed and analyzed by MD Andersen RPPA Facility.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 changes represent the mean from two biological replicates. Cutoff values for significant alterations were set at 25%.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56787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323850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3653224-8AAE-464A-B1BD-5DDE7AA8F9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0697994"/>
              </p:ext>
            </p:extLst>
          </p:nvPr>
        </p:nvGraphicFramePr>
        <p:xfrm>
          <a:off x="1371600" y="1296013"/>
          <a:ext cx="3886200" cy="2419350"/>
        </p:xfrm>
        <a:graphic>
          <a:graphicData uri="http://schemas.openxmlformats.org/drawingml/2006/table">
            <a:tbl>
              <a:tblPr/>
              <a:tblGrid>
                <a:gridCol w="1943100">
                  <a:extLst>
                    <a:ext uri="{9D8B030D-6E8A-4147-A177-3AD203B41FA5}">
                      <a16:colId xmlns:a16="http://schemas.microsoft.com/office/drawing/2014/main" val="3158289190"/>
                    </a:ext>
                  </a:extLst>
                </a:gridCol>
                <a:gridCol w="1943100">
                  <a:extLst>
                    <a:ext uri="{9D8B030D-6E8A-4147-A177-3AD203B41FA5}">
                      <a16:colId xmlns:a16="http://schemas.microsoft.com/office/drawing/2014/main" val="770977370"/>
                    </a:ext>
                  </a:extLst>
                </a:gridCol>
              </a:tblGrid>
              <a:tr h="257175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S5. Flavone IC</a:t>
                      </a:r>
                      <a:r>
                        <a:rPr lang="en-US" sz="12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alues in HT-29 cell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6023416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ponent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C</a:t>
                      </a:r>
                      <a:r>
                        <a:rPr lang="en-US" sz="12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(µ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3420904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ical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.38 ± 5.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0080116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icale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8.29 ± 19.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3870573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ogon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.07 ± 14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4100464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ogonosid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gt;300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642087"/>
                  </a:ext>
                </a:extLst>
              </a:tr>
              <a:tr h="447675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l IC</a:t>
                      </a:r>
                      <a:r>
                        <a:rPr lang="en-US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lues represent the mean ± SD from 3-5 independent experiments.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67437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24819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914</TotalTime>
  <Words>366</Words>
  <Application>Microsoft Macintosh PowerPoint</Application>
  <PresentationFormat>Letter Paper (8.5x11 in)</PresentationFormat>
  <Paragraphs>11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Haizhou</dc:creator>
  <cp:lastModifiedBy>Schmitz, John</cp:lastModifiedBy>
  <cp:revision>2815</cp:revision>
  <cp:lastPrinted>2020-02-21T18:54:40Z</cp:lastPrinted>
  <dcterms:created xsi:type="dcterms:W3CDTF">2012-09-12T18:30:13Z</dcterms:created>
  <dcterms:modified xsi:type="dcterms:W3CDTF">2023-01-04T20:17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2-11-01T22:12:02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755ba309-69c2-443e-864d-fe500a1a99e6</vt:lpwstr>
  </property>
  <property fmtid="{D5CDD505-2E9C-101B-9397-08002B2CF9AE}" pid="8" name="MSIP_Label_5e4b1be8-281e-475d-98b0-21c3457e5a46_ContentBits">
    <vt:lpwstr>0</vt:lpwstr>
  </property>
</Properties>
</file>